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751599-D7C2-4655-BD64-CF737EF316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D166F2-C556-4410-B86E-1CCCB8DA91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AF7BCC-8F53-4101-93AF-A47D040C9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2ABDC2-DC9B-4493-B336-ECD05DA02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4B2E6-CDE7-48F6-846B-D71E594AD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0122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63E50-8F68-49AC-B61A-AA10244D3F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83DB37-4C2C-463B-8C11-36ECA42201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A958C6-E15C-4C1D-9B7F-7E4377414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AAE71-754F-4E51-A984-34607D4B5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1CA706-6212-4603-9CEB-B6CB12048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9121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5E6FA0-4D67-446F-BCC6-511536C2A3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0985AC-76B6-4252-BDDE-55AF9ED959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FBE5C-D271-45F5-90F3-3EFAD8F22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31EBFD-009D-4D13-9365-E5087B6F0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71098-1F50-4AF8-8D53-DF803075F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3651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9D655-1C80-46D1-BEC9-9D8879792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FC32EC-61DF-471A-9CA7-FD42C52DE7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2E71BC-8C64-4FC2-8B0A-069E7C36B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DB846-A5F2-4322-8FA4-D36FF5EC9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8436E6-C1D2-4C23-8C35-4C9844175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1930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BDA01-3984-43F9-83BF-DD116FB78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7E30A-3D42-4DCB-A721-8981B6D118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076CD-164D-4B7E-AC9A-3D3A2970B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86599-F0BC-4AF2-9C93-B965C82D1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7DF94-FDD2-481D-BAA2-F97C820C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64910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1EB5C-B1FE-4C44-91AD-8E1115604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C8DE69-E8EB-4606-A88A-2622E68883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3800C6-43D3-4232-9912-117DCD10B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FDC040-4EC3-41B6-866F-4CBC7DD95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0455F-5636-4E34-8CF2-5238F27E4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D5B878-C6C5-4FD4-89DE-49979D0FC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365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BC184-76F5-480F-A658-BEE41FEF82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F92054-7D01-4D27-BC82-E5EDC8997D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B56188-FE71-48A3-BD78-13174D003B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A42C47-915D-41B4-8AB5-29E9A2B3ED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6A8116-410A-4840-BE3D-C2590D5435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9823BA-21E7-4F28-BB24-061F657B2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955205-80CB-42AD-920A-77808A794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A4EE14-AABC-41AD-8F60-3D8784E11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5640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0436F-4A0D-426D-9166-CD03E7757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E4DEBE-F7E2-4D20-8E11-E3A23AA63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F244D1-A8FA-42CB-AF0B-592D53419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AE9438D-5F58-4C2A-95F6-0ED55C649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4194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B469F8-B415-4D1C-A0D3-26E3482CB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B8E53A-0825-4B9A-9044-84CE12408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4903F6-F349-49BB-A2AB-30506B87D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7184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96F12-12DE-4669-985C-0041E9CD3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AC6829-6D58-459E-B78C-0384687CCF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9722C0-616D-4291-9AFA-B7E9E9BC71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3B17AC-D998-42D8-AF16-F2607EA4D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471D0E-FFB9-4E3C-A8B4-D430C8A12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EED8E5-CEFF-487B-968B-51D968F18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9200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35408-C846-4BBB-80BA-7B6B7A0773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974ADB-BB4A-44C2-81CA-BA2FD71FD8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FACDB8-C543-4A03-BCC3-B561D8644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EE054F-367E-4456-BDB2-063ADF0A5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E7CEB9-7790-488E-8180-1DB42DFA7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FA48C8-EA15-4C3F-909C-8D04D4599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0341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607003-6BAF-4933-966D-23CF76DDE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E585FF-031A-4CBA-A57C-0CF8CE644D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B949E0-8E5F-4C83-BFF8-A6AF83873F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04BE-7680-4253-9753-3C5FD2579A3D}" type="datetimeFigureOut">
              <a:rPr lang="en-IN" smtClean="0"/>
              <a:t>06-06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BF0EBE-B8FA-4466-89CB-F1AFC40A82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7864D-ED24-40F6-9BB2-AAF309B6F3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5D463-0039-40A3-9C90-A8D8C2D5E6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8984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03971024-612B-4141-85AD-964782F547E3}"/>
              </a:ext>
            </a:extLst>
          </p:cNvPr>
          <p:cNvGrpSpPr/>
          <p:nvPr/>
        </p:nvGrpSpPr>
        <p:grpSpPr>
          <a:xfrm>
            <a:off x="1414731" y="130613"/>
            <a:ext cx="9665684" cy="6460688"/>
            <a:chOff x="338406" y="216338"/>
            <a:chExt cx="9665684" cy="646068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44987B5-FB6F-4ADC-BAB2-43303C9765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7739" y="216338"/>
              <a:ext cx="4178129" cy="209823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9A93985-3A23-475C-8B4F-17D289B781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7738" y="2423288"/>
              <a:ext cx="4178129" cy="201142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9D7D90C-08A0-4E36-8C81-B669067ECD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7738" y="4543426"/>
              <a:ext cx="4178129" cy="21336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3CAFB8A-8CA4-46A4-91EE-D4772C0AFDFD}"/>
                </a:ext>
              </a:extLst>
            </p:cNvPr>
            <p:cNvSpPr txBox="1"/>
            <p:nvPr/>
          </p:nvSpPr>
          <p:spPr>
            <a:xfrm rot="16200000">
              <a:off x="-415655" y="1080789"/>
              <a:ext cx="187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ery protein-1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4CCE9D4-7C13-4FF9-92CB-85C0FCA290F0}"/>
                </a:ext>
              </a:extLst>
            </p:cNvPr>
            <p:cNvSpPr txBox="1"/>
            <p:nvPr/>
          </p:nvSpPr>
          <p:spPr>
            <a:xfrm rot="16200000">
              <a:off x="-415654" y="3244334"/>
              <a:ext cx="187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ery protein-2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C0EF719-1056-4AAF-BD12-AEC04F0FD31D}"/>
                </a:ext>
              </a:extLst>
            </p:cNvPr>
            <p:cNvSpPr txBox="1"/>
            <p:nvPr/>
          </p:nvSpPr>
          <p:spPr>
            <a:xfrm rot="16200000">
              <a:off x="-415655" y="5297488"/>
              <a:ext cx="187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ery protein-3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047E39F8-15CB-42DD-8413-8D10A340C74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3078" y="216338"/>
              <a:ext cx="4291012" cy="215492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5965B6D-0EA0-466A-8F48-8AAC7037DA8E}"/>
                </a:ext>
              </a:extLst>
            </p:cNvPr>
            <p:cNvSpPr txBox="1"/>
            <p:nvPr/>
          </p:nvSpPr>
          <p:spPr>
            <a:xfrm rot="16200000">
              <a:off x="4451622" y="1109134"/>
              <a:ext cx="187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elatococcus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p.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CA7BD44-F602-41CF-9624-99D0D02314C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3078" y="2341040"/>
              <a:ext cx="4291012" cy="2154925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3581177-718E-43CB-82F9-5DBACC834F72}"/>
                </a:ext>
              </a:extLst>
            </p:cNvPr>
            <p:cNvSpPr txBox="1"/>
            <p:nvPr/>
          </p:nvSpPr>
          <p:spPr>
            <a:xfrm rot="16200000">
              <a:off x="4520654" y="2863643"/>
              <a:ext cx="187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sea</a:t>
              </a:r>
              <a:r>
                <a:rPr lang="en-US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.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0BC6F05E-A245-4CF1-ACE6-0A9149677C9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9763" y="4448224"/>
              <a:ext cx="4178129" cy="209823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E966540-9848-4C21-A72B-8DDFCB28EEC0}"/>
                </a:ext>
              </a:extLst>
            </p:cNvPr>
            <p:cNvSpPr txBox="1"/>
            <p:nvPr/>
          </p:nvSpPr>
          <p:spPr>
            <a:xfrm rot="16200000">
              <a:off x="4317676" y="5297487"/>
              <a:ext cx="23690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obacterium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p.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07970EC-5595-4F20-8CA6-2D7C9918E3E2}"/>
              </a:ext>
            </a:extLst>
          </p:cNvPr>
          <p:cNvSpPr txBox="1"/>
          <p:nvPr/>
        </p:nvSpPr>
        <p:spPr>
          <a:xfrm rot="16200000">
            <a:off x="-2066266" y="3017747"/>
            <a:ext cx="518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 peptide prediction using </a:t>
            </a:r>
            <a:r>
              <a:rPr lang="en-US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P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5.0 server</a:t>
            </a:r>
            <a:endParaRPr lang="en-IN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5482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ti</dc:creator>
  <cp:lastModifiedBy>Kriti</cp:lastModifiedBy>
  <cp:revision>3</cp:revision>
  <dcterms:created xsi:type="dcterms:W3CDTF">2020-06-05T17:25:56Z</dcterms:created>
  <dcterms:modified xsi:type="dcterms:W3CDTF">2020-06-06T15:35:40Z</dcterms:modified>
</cp:coreProperties>
</file>